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120" y="7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C272F4-F2E4-40BF-807B-086990C7B43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FF1EFA4-E4FC-4092-AA2E-A74A8A6F12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C35704-A4CA-4EA4-80B9-B5308965B8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05D41-30AE-4501-BEA2-53812A3BFADC}" type="datetimeFigureOut">
              <a:rPr lang="en-US" smtClean="0"/>
              <a:t>5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744546-C55E-4AC3-8E79-1E19B15948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0F376F-E210-445C-9FF3-D355F1CD0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69DA0-B065-4BA1-8BB5-76F9E2F7F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160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2274C1-63AF-411F-850E-F136B91879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B03AC04-6D6D-4EB1-AAFC-22CB2F69EA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596D25-AD2E-4539-B5C9-6276DBF73D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05D41-30AE-4501-BEA2-53812A3BFADC}" type="datetimeFigureOut">
              <a:rPr lang="en-US" smtClean="0"/>
              <a:t>5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EC1848-A00F-4487-A88C-871235B3A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78C695-51D5-4677-851F-79D8984A99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69DA0-B065-4BA1-8BB5-76F9E2F7F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71889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1C165D2-04AE-4696-B3B3-893EF90FC6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EE84A8-3494-41A5-AF46-56DD3FA075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092F19-13BE-42AD-AF12-334D1CD551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05D41-30AE-4501-BEA2-53812A3BFADC}" type="datetimeFigureOut">
              <a:rPr lang="en-US" smtClean="0"/>
              <a:t>5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4A9BFD-32CA-48EA-A53B-698BE31EA8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DAA553-096A-48CC-9692-EE10188B39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69DA0-B065-4BA1-8BB5-76F9E2F7F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1302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B1C0E7-6595-4C50-95BC-9A04A187E2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857691-92B7-4325-A1D0-2A431BCAE7E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459EA3-69A5-4FD1-867F-69DDFE9AC5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05D41-30AE-4501-BEA2-53812A3BFADC}" type="datetimeFigureOut">
              <a:rPr lang="en-US" smtClean="0"/>
              <a:t>5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25176B-FF9F-4517-897B-55084E6A3C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6F3992-FBDB-454D-ABC4-8DB32A620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69DA0-B065-4BA1-8BB5-76F9E2F7F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2867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39B3D8-16F7-482D-AA37-2C4007D6B1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C9A1B3-D1EF-4F6F-87C5-1F44816887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A81CCB-DA1A-4DEB-9EF0-1C49E249B7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05D41-30AE-4501-BEA2-53812A3BFADC}" type="datetimeFigureOut">
              <a:rPr lang="en-US" smtClean="0"/>
              <a:t>5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9F4C3A-3A2D-48A2-94CF-2C0158D100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73E8D3-FDCD-40E2-8DE9-2FDF003FD7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69DA0-B065-4BA1-8BB5-76F9E2F7F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60514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BD84A8-2835-4652-83D6-C66F2F2A6F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4512F9-69DB-425D-87BA-35B95B5105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11296E7-B2CA-420F-9BF0-A468A9C00F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35C15D-A9C3-4E9D-AC81-20D9F41D6C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05D41-30AE-4501-BEA2-53812A3BFADC}" type="datetimeFigureOut">
              <a:rPr lang="en-US" smtClean="0"/>
              <a:t>5/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81471F-1EB8-45E3-A849-7B13E88783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E29575-EBAD-4F73-BDA6-EEDEFEC298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69DA0-B065-4BA1-8BB5-76F9E2F7F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2795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716A05-BAAE-49B3-A678-44609A8D3A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A40061-E138-4920-8DD1-92E6543BB7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131248C-C02B-4DC4-AF70-87CD751CFA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D10498D-C789-4A8A-AD82-33EAF69153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3838A3A-7743-4787-92DD-E502F543ED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F4AECDB-8C69-4EAA-B426-3178CE4B07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05D41-30AE-4501-BEA2-53812A3BFADC}" type="datetimeFigureOut">
              <a:rPr lang="en-US" smtClean="0"/>
              <a:t>5/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4A2437B-DC70-40FC-BC9B-39F7AE7DAC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5A056C1-8D7F-4430-8017-560E610A5A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69DA0-B065-4BA1-8BB5-76F9E2F7F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74508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964CE0-0EC5-45A0-A5E9-3F62A46516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FD996C1-EDD6-4318-B5F2-E767F0FDDA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05D41-30AE-4501-BEA2-53812A3BFADC}" type="datetimeFigureOut">
              <a:rPr lang="en-US" smtClean="0"/>
              <a:t>5/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2C3C0A7-A43F-4C8F-B247-81FCDFBEA3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1B0C95C-1F38-4168-97FA-DEF9E998D0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69DA0-B065-4BA1-8BB5-76F9E2F7F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74916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41AECB-37E7-44E8-86F2-9A075E5C04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05D41-30AE-4501-BEA2-53812A3BFADC}" type="datetimeFigureOut">
              <a:rPr lang="en-US" smtClean="0"/>
              <a:t>5/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05239E3-6B95-4D86-9FD0-8991F1AF1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854FA4-EACA-4088-AFD8-0B709FEF67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69DA0-B065-4BA1-8BB5-76F9E2F7F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11908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CC787C-501B-433B-96B4-4B5E4B4FEE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FBF758-A10B-4F05-A779-E71918C9E29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81843EC-FF6B-4101-A1A0-503D4F820C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361263B-4CC3-4D2B-811D-F0D020E172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05D41-30AE-4501-BEA2-53812A3BFADC}" type="datetimeFigureOut">
              <a:rPr lang="en-US" smtClean="0"/>
              <a:t>5/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D47E0D-AABF-4525-BA2D-4AD10D5643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ED5801-DAA8-4B59-97EA-CD7118EF8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69DA0-B065-4BA1-8BB5-76F9E2F7F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7688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293D6E-FA2A-4A09-A97D-76B257E4A2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494E910-A503-4869-B6C9-04BC272019E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6DA7800-3030-467E-9E3B-5CDF5BA9CF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2AF3FD-6392-4729-9B1D-46DF6AC11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05D41-30AE-4501-BEA2-53812A3BFADC}" type="datetimeFigureOut">
              <a:rPr lang="en-US" smtClean="0"/>
              <a:t>5/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70F41E-50F8-472A-BFB6-7F40252B78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AE96FB-8F58-47DE-A36D-22F0CB5562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69DA0-B065-4BA1-8BB5-76F9E2F7F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6961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70CD3B5-6402-475F-BFFC-5F4A439F98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57EFD2-0378-4B7E-AD9E-A3CE05378C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791AD0-E1B4-4B9B-8E03-D7906066D6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605D41-30AE-4501-BEA2-53812A3BFADC}" type="datetimeFigureOut">
              <a:rPr lang="en-US" smtClean="0"/>
              <a:t>5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EE34C0-2E72-44EE-B5A1-730274E5412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0EFAAE-D833-4ED1-AB5E-01A93B4A86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269DA0-B065-4BA1-8BB5-76F9E2F7F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2355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outdoor, white&#10;&#10;Description automatically generated">
            <a:extLst>
              <a:ext uri="{FF2B5EF4-FFF2-40B4-BE49-F238E27FC236}">
                <a16:creationId xmlns:a16="http://schemas.microsoft.com/office/drawing/2014/main" id="{B7364B5B-3330-4CF4-AC23-3E662838AD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151" y="2248392"/>
            <a:ext cx="6015060" cy="4494641"/>
          </a:xfrm>
          <a:prstGeom prst="rect">
            <a:avLst/>
          </a:prstGeom>
        </p:spPr>
      </p:pic>
      <p:pic>
        <p:nvPicPr>
          <p:cNvPr id="9" name="Picture 8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39C10749-7688-4BBF-8613-B8694D7D970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9900" y="2745334"/>
            <a:ext cx="5428335" cy="4045507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D325686-E2CA-4974-BB69-1EE20DDDBE41}"/>
              </a:ext>
            </a:extLst>
          </p:cNvPr>
          <p:cNvSpPr txBox="1"/>
          <p:nvPr/>
        </p:nvSpPr>
        <p:spPr>
          <a:xfrm rot="16200000">
            <a:off x="1344476" y="2775264"/>
            <a:ext cx="898003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RCA2</a:t>
            </a:r>
            <a:r>
              <a:rPr lang="es-E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3F930D8-7CA0-4055-AB18-4E1E3FDB126D}"/>
              </a:ext>
            </a:extLst>
          </p:cNvPr>
          <p:cNvSpPr txBox="1"/>
          <p:nvPr/>
        </p:nvSpPr>
        <p:spPr>
          <a:xfrm rot="16200000">
            <a:off x="1485340" y="2673173"/>
            <a:ext cx="1112805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8E2E949-6D3E-4478-8D20-4F6509BA89C3}"/>
              </a:ext>
            </a:extLst>
          </p:cNvPr>
          <p:cNvSpPr txBox="1"/>
          <p:nvPr/>
        </p:nvSpPr>
        <p:spPr>
          <a:xfrm rot="16200000">
            <a:off x="1872779" y="2799022"/>
            <a:ext cx="822661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S1221P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1B829B9-143B-47B2-80AC-8428A05A7F5F}"/>
              </a:ext>
            </a:extLst>
          </p:cNvPr>
          <p:cNvSpPr txBox="1"/>
          <p:nvPr/>
        </p:nvSpPr>
        <p:spPr>
          <a:xfrm rot="16200000">
            <a:off x="2161918" y="2849511"/>
            <a:ext cx="740908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T1346I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11E7392-5414-45CD-A81D-BA5777C1ACE5}"/>
              </a:ext>
            </a:extLst>
          </p:cNvPr>
          <p:cNvSpPr txBox="1"/>
          <p:nvPr/>
        </p:nvSpPr>
        <p:spPr>
          <a:xfrm rot="16200000">
            <a:off x="2404285" y="2839899"/>
            <a:ext cx="740908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DE8F32AC-FE38-4030-951D-EE70C767BD78}"/>
              </a:ext>
            </a:extLst>
          </p:cNvPr>
          <p:cNvSpPr/>
          <p:nvPr/>
        </p:nvSpPr>
        <p:spPr>
          <a:xfrm>
            <a:off x="1609834" y="3710597"/>
            <a:ext cx="1219429" cy="4095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276998F6-DCB6-4175-9522-2EAE37BB29E9}"/>
              </a:ext>
            </a:extLst>
          </p:cNvPr>
          <p:cNvSpPr/>
          <p:nvPr/>
        </p:nvSpPr>
        <p:spPr>
          <a:xfrm>
            <a:off x="7046579" y="3505804"/>
            <a:ext cx="1219429" cy="4095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BF3D0DF9-3ED5-4524-87F3-C5EA649D9609}"/>
              </a:ext>
            </a:extLst>
          </p:cNvPr>
          <p:cNvSpPr/>
          <p:nvPr/>
        </p:nvSpPr>
        <p:spPr>
          <a:xfrm>
            <a:off x="7046578" y="5368669"/>
            <a:ext cx="1247281" cy="4095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E072C19-7112-466A-A681-9581CB82CC1A}"/>
              </a:ext>
            </a:extLst>
          </p:cNvPr>
          <p:cNvSpPr txBox="1"/>
          <p:nvPr/>
        </p:nvSpPr>
        <p:spPr>
          <a:xfrm rot="16200000">
            <a:off x="6759484" y="2985898"/>
            <a:ext cx="898003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RCA2</a:t>
            </a:r>
            <a:r>
              <a:rPr lang="es-E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68E64C8-BC23-4217-B9F8-F112637D1CD2}"/>
              </a:ext>
            </a:extLst>
          </p:cNvPr>
          <p:cNvSpPr txBox="1"/>
          <p:nvPr/>
        </p:nvSpPr>
        <p:spPr>
          <a:xfrm rot="16200000">
            <a:off x="6900348" y="2883807"/>
            <a:ext cx="1112805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29B9503-FFB6-49D2-8612-A9D3924F8FEF}"/>
              </a:ext>
            </a:extLst>
          </p:cNvPr>
          <p:cNvSpPr txBox="1"/>
          <p:nvPr/>
        </p:nvSpPr>
        <p:spPr>
          <a:xfrm rot="16200000">
            <a:off x="7287787" y="3009656"/>
            <a:ext cx="822661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S1221P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708FDA5-85F8-4BB9-832F-D709751C88BC}"/>
              </a:ext>
            </a:extLst>
          </p:cNvPr>
          <p:cNvSpPr txBox="1"/>
          <p:nvPr/>
        </p:nvSpPr>
        <p:spPr>
          <a:xfrm rot="16200000">
            <a:off x="7576926" y="3060145"/>
            <a:ext cx="740908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T1346I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9070737-6097-4D4B-80DC-E0405FCECE1C}"/>
              </a:ext>
            </a:extLst>
          </p:cNvPr>
          <p:cNvSpPr txBox="1"/>
          <p:nvPr/>
        </p:nvSpPr>
        <p:spPr>
          <a:xfrm rot="16200000">
            <a:off x="7819293" y="3050533"/>
            <a:ext cx="740908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E7A981B-28E3-4739-A76C-F79C58487FA2}"/>
              </a:ext>
            </a:extLst>
          </p:cNvPr>
          <p:cNvSpPr txBox="1"/>
          <p:nvPr/>
        </p:nvSpPr>
        <p:spPr>
          <a:xfrm rot="16200000">
            <a:off x="6709708" y="4839950"/>
            <a:ext cx="898003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RCA2</a:t>
            </a:r>
            <a:r>
              <a:rPr lang="es-E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3E93825-9686-4083-9CD8-E64FA499179F}"/>
              </a:ext>
            </a:extLst>
          </p:cNvPr>
          <p:cNvSpPr txBox="1"/>
          <p:nvPr/>
        </p:nvSpPr>
        <p:spPr>
          <a:xfrm rot="16200000">
            <a:off x="6850572" y="4737859"/>
            <a:ext cx="1112805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B1C2260-7B45-4A8B-88CE-D5F4D6FB1E92}"/>
              </a:ext>
            </a:extLst>
          </p:cNvPr>
          <p:cNvSpPr txBox="1"/>
          <p:nvPr/>
        </p:nvSpPr>
        <p:spPr>
          <a:xfrm rot="16200000">
            <a:off x="7238011" y="4863708"/>
            <a:ext cx="822661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S1221P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E664FAB-9576-4A27-A65D-0737B677C399}"/>
              </a:ext>
            </a:extLst>
          </p:cNvPr>
          <p:cNvSpPr txBox="1"/>
          <p:nvPr/>
        </p:nvSpPr>
        <p:spPr>
          <a:xfrm rot="16200000">
            <a:off x="7527150" y="4914197"/>
            <a:ext cx="740908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T1346I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ED100CC-0757-4512-AD32-67A13FD82147}"/>
              </a:ext>
            </a:extLst>
          </p:cNvPr>
          <p:cNvSpPr txBox="1"/>
          <p:nvPr/>
        </p:nvSpPr>
        <p:spPr>
          <a:xfrm rot="16200000">
            <a:off x="7769517" y="4904585"/>
            <a:ext cx="740908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B1AD710-CC99-4D33-BB43-3A20DF0B06ED}"/>
              </a:ext>
            </a:extLst>
          </p:cNvPr>
          <p:cNvSpPr txBox="1"/>
          <p:nvPr/>
        </p:nvSpPr>
        <p:spPr>
          <a:xfrm>
            <a:off x="278151" y="3750851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tain Fre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3B09235-5119-4E3F-A050-B1E52B2591EC}"/>
              </a:ext>
            </a:extLst>
          </p:cNvPr>
          <p:cNvSpPr txBox="1"/>
          <p:nvPr/>
        </p:nvSpPr>
        <p:spPr>
          <a:xfrm>
            <a:off x="6050429" y="3483498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RCA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E6236D5-266B-4565-8AAD-17F3D282F170}"/>
              </a:ext>
            </a:extLst>
          </p:cNvPr>
          <p:cNvSpPr txBox="1"/>
          <p:nvPr/>
        </p:nvSpPr>
        <p:spPr>
          <a:xfrm>
            <a:off x="6107977" y="5400747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BF6A4029-6EBC-4416-B0D4-37D3B33B3DCC}"/>
              </a:ext>
            </a:extLst>
          </p:cNvPr>
          <p:cNvGrpSpPr/>
          <p:nvPr/>
        </p:nvGrpSpPr>
        <p:grpSpPr>
          <a:xfrm>
            <a:off x="974703" y="-10725"/>
            <a:ext cx="3260793" cy="2087835"/>
            <a:chOff x="398070" y="-5166"/>
            <a:chExt cx="2558065" cy="1567993"/>
          </a:xfrm>
        </p:grpSpPr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B1203484-3D56-446B-AED4-49EB330FD4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864" t="21730" r="58078" b="71178"/>
            <a:stretch/>
          </p:blipFill>
          <p:spPr>
            <a:xfrm>
              <a:off x="909512" y="777317"/>
              <a:ext cx="1270467" cy="25634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97FCF086-00DC-4D70-AC1F-907E6EA42A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864" t="66465" r="57911" b="26442"/>
            <a:stretch/>
          </p:blipFill>
          <p:spPr>
            <a:xfrm>
              <a:off x="909512" y="1072884"/>
              <a:ext cx="1278938" cy="25634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58A2BFD1-D83F-47C8-85F7-F9EA236CEA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098" t="34069" r="56691" b="61754"/>
            <a:stretch/>
          </p:blipFill>
          <p:spPr>
            <a:xfrm>
              <a:off x="909512" y="1371625"/>
              <a:ext cx="1278938" cy="17191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96EAF4E3-E756-46DC-8EC7-B03B47EC8BEF}"/>
                </a:ext>
              </a:extLst>
            </p:cNvPr>
            <p:cNvSpPr txBox="1"/>
            <p:nvPr/>
          </p:nvSpPr>
          <p:spPr>
            <a:xfrm rot="16200000">
              <a:off x="805339" y="372636"/>
              <a:ext cx="674413" cy="2414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>
                  <a:latin typeface="Arial" panose="020B0604020202020204" pitchFamily="34" charset="0"/>
                  <a:cs typeface="Arial" panose="020B0604020202020204" pitchFamily="34" charset="0"/>
                </a:rPr>
                <a:t>BRCA2</a:t>
              </a:r>
              <a:r>
                <a:rPr lang="es-ES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73B8D91E-7A91-4A44-8A15-86E120164D72}"/>
                </a:ext>
              </a:extLst>
            </p:cNvPr>
            <p:cNvSpPr txBox="1"/>
            <p:nvPr/>
          </p:nvSpPr>
          <p:spPr>
            <a:xfrm rot="16200000">
              <a:off x="990798" y="291976"/>
              <a:ext cx="835732" cy="2414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>
                  <a:latin typeface="Arial" panose="020B0604020202020204" pitchFamily="34" charset="0"/>
                  <a:cs typeface="Arial" panose="020B0604020202020204" pitchFamily="34" charset="0"/>
                </a:rPr>
                <a:t>BRCA2 WT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F1AFD733-02CF-416F-BFDD-482218BD4554}"/>
                </a:ext>
              </a:extLst>
            </p:cNvPr>
            <p:cNvSpPr txBox="1"/>
            <p:nvPr/>
          </p:nvSpPr>
          <p:spPr>
            <a:xfrm rot="16200000">
              <a:off x="1328803" y="400927"/>
              <a:ext cx="617830" cy="2414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>
                  <a:latin typeface="Arial" panose="020B0604020202020204" pitchFamily="34" charset="0"/>
                  <a:cs typeface="Arial" panose="020B0604020202020204" pitchFamily="34" charset="0"/>
                </a:rPr>
                <a:t>S1221P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7FFD6990-6974-4C5D-86E3-D3DC7CAF7799}"/>
                </a:ext>
              </a:extLst>
            </p:cNvPr>
            <p:cNvSpPr txBox="1"/>
            <p:nvPr/>
          </p:nvSpPr>
          <p:spPr>
            <a:xfrm rot="16200000">
              <a:off x="1562591" y="431626"/>
              <a:ext cx="556432" cy="2414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>
                  <a:latin typeface="Arial" panose="020B0604020202020204" pitchFamily="34" charset="0"/>
                  <a:cs typeface="Arial" panose="020B0604020202020204" pitchFamily="34" charset="0"/>
                </a:rPr>
                <a:t>T1346I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174468F5-64AE-4AA6-87A5-0A5224AD34B2}"/>
                </a:ext>
              </a:extLst>
            </p:cNvPr>
            <p:cNvSpPr txBox="1"/>
            <p:nvPr/>
          </p:nvSpPr>
          <p:spPr>
            <a:xfrm rot="16200000">
              <a:off x="1748535" y="431626"/>
              <a:ext cx="556432" cy="2414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>
                  <a:latin typeface="Arial" panose="020B0604020202020204" pitchFamily="34" charset="0"/>
                  <a:cs typeface="Arial" panose="020B0604020202020204" pitchFamily="34" charset="0"/>
                </a:rPr>
                <a:t>T1980I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EE4CF646-8974-4CC1-9F82-4A779DFF31E3}"/>
                </a:ext>
              </a:extLst>
            </p:cNvPr>
            <p:cNvSpPr txBox="1"/>
            <p:nvPr/>
          </p:nvSpPr>
          <p:spPr>
            <a:xfrm>
              <a:off x="398070" y="862941"/>
              <a:ext cx="517101" cy="184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A367BE31-DF9C-428F-A939-062830894B98}"/>
                </a:ext>
              </a:extLst>
            </p:cNvPr>
            <p:cNvCxnSpPr/>
            <p:nvPr/>
          </p:nvCxnSpPr>
          <p:spPr>
            <a:xfrm>
              <a:off x="841961" y="954956"/>
              <a:ext cx="5738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0A624DA1-2900-46E2-9EA7-75299CF80EAA}"/>
                </a:ext>
              </a:extLst>
            </p:cNvPr>
            <p:cNvSpPr txBox="1"/>
            <p:nvPr/>
          </p:nvSpPr>
          <p:spPr>
            <a:xfrm>
              <a:off x="404358" y="1105853"/>
              <a:ext cx="517101" cy="184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 37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19CAE126-5C8F-4DEF-841B-1485E04F752D}"/>
                </a:ext>
              </a:extLst>
            </p:cNvPr>
            <p:cNvSpPr txBox="1"/>
            <p:nvPr/>
          </p:nvSpPr>
          <p:spPr>
            <a:xfrm>
              <a:off x="2121597" y="799657"/>
              <a:ext cx="823942" cy="2311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RCA2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9C40B16E-7901-4388-A6B4-0179AF32675D}"/>
                </a:ext>
              </a:extLst>
            </p:cNvPr>
            <p:cNvSpPr txBox="1"/>
            <p:nvPr/>
          </p:nvSpPr>
          <p:spPr>
            <a:xfrm>
              <a:off x="2132193" y="1107001"/>
              <a:ext cx="606387" cy="2311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RAD51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8F86B605-B8E3-4BDF-B98F-4503AE1E63A3}"/>
                </a:ext>
              </a:extLst>
            </p:cNvPr>
            <p:cNvSpPr txBox="1"/>
            <p:nvPr/>
          </p:nvSpPr>
          <p:spPr>
            <a:xfrm>
              <a:off x="2132193" y="1331682"/>
              <a:ext cx="823942" cy="2311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tain Fre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564873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41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menez Sainz, Judit</dc:creator>
  <cp:lastModifiedBy>Jimenez Sainz, Judit</cp:lastModifiedBy>
  <cp:revision>1</cp:revision>
  <dcterms:created xsi:type="dcterms:W3CDTF">2022-05-02T18:21:51Z</dcterms:created>
  <dcterms:modified xsi:type="dcterms:W3CDTF">2022-05-02T18:46:53Z</dcterms:modified>
</cp:coreProperties>
</file>